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F304D66-4067-4D7B-8C86-9AED6913CBAE}" v="2" dt="2022-06-23T04:43:37.4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9" d="100"/>
          <a:sy n="99" d="100"/>
        </p:scale>
        <p:origin x="5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ianne Campbell" userId="221e60a4-dfd8-4552-88b6-64bd2a28d228" providerId="ADAL" clId="{9F304D66-4067-4D7B-8C86-9AED6913CBAE}"/>
    <pc:docChg chg="addSld delSld modSld">
      <pc:chgData name="Dianne Campbell" userId="221e60a4-dfd8-4552-88b6-64bd2a28d228" providerId="ADAL" clId="{9F304D66-4067-4D7B-8C86-9AED6913CBAE}" dt="2022-07-07T06:19:49.541" v="15" actId="20577"/>
      <pc:docMkLst>
        <pc:docMk/>
      </pc:docMkLst>
      <pc:sldChg chg="modSp mod">
        <pc:chgData name="Dianne Campbell" userId="221e60a4-dfd8-4552-88b6-64bd2a28d228" providerId="ADAL" clId="{9F304D66-4067-4D7B-8C86-9AED6913CBAE}" dt="2022-07-07T06:19:49.541" v="15" actId="20577"/>
        <pc:sldMkLst>
          <pc:docMk/>
          <pc:sldMk cId="2078845912" sldId="261"/>
        </pc:sldMkLst>
        <pc:spChg chg="mod">
          <ac:chgData name="Dianne Campbell" userId="221e60a4-dfd8-4552-88b6-64bd2a28d228" providerId="ADAL" clId="{9F304D66-4067-4D7B-8C86-9AED6913CBAE}" dt="2022-07-07T06:19:49.541" v="15" actId="20577"/>
          <ac:spMkLst>
            <pc:docMk/>
            <pc:sldMk cId="2078845912" sldId="261"/>
            <ac:spMk id="3" creationId="{B623DEEE-D4E7-42CC-816C-0005993BF80A}"/>
          </ac:spMkLst>
        </pc:spChg>
      </pc:sldChg>
      <pc:sldChg chg="addSp modSp new del mod">
        <pc:chgData name="Dianne Campbell" userId="221e60a4-dfd8-4552-88b6-64bd2a28d228" providerId="ADAL" clId="{9F304D66-4067-4D7B-8C86-9AED6913CBAE}" dt="2022-06-23T04:49:20.041" v="6" actId="2696"/>
        <pc:sldMkLst>
          <pc:docMk/>
          <pc:sldMk cId="1160946794" sldId="262"/>
        </pc:sldMkLst>
        <pc:spChg chg="add mod">
          <ac:chgData name="Dianne Campbell" userId="221e60a4-dfd8-4552-88b6-64bd2a28d228" providerId="ADAL" clId="{9F304D66-4067-4D7B-8C86-9AED6913CBAE}" dt="2022-06-23T04:43:14.638" v="3" actId="20577"/>
          <ac:spMkLst>
            <pc:docMk/>
            <pc:sldMk cId="1160946794" sldId="262"/>
            <ac:spMk id="2" creationId="{F6B1BCE8-6F5F-7F44-2944-3A923ED3A711}"/>
          </ac:spMkLst>
        </pc:spChg>
        <pc:graphicFrameChg chg="add mod">
          <ac:chgData name="Dianne Campbell" userId="221e60a4-dfd8-4552-88b6-64bd2a28d228" providerId="ADAL" clId="{9F304D66-4067-4D7B-8C86-9AED6913CBAE}" dt="2022-06-23T04:43:39.802" v="5" actId="1076"/>
          <ac:graphicFrameMkLst>
            <pc:docMk/>
            <pc:sldMk cId="1160946794" sldId="262"/>
            <ac:graphicFrameMk id="3" creationId="{67262299-3095-F160-973B-1CBB6D85FB6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E7A661-AA47-46F1-9CEC-0D20072DBD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D9636D-4B4E-4722-A154-F6B421912E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A19402-EFC4-4E80-B11E-2FF2DD920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3E5FA5-82BA-4675-96EF-01BD6DF14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9F2D14-59E3-4F97-A0A7-EE3111D94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155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030C9-467C-4243-A87D-53EB52DCC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A1297B-28B4-4B28-BA06-4C99E4EB16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C96439-E4B1-40B0-82E7-AB45D6FE5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8304A1-215D-452C-92BF-E349EABAD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1A2463-D669-4F87-82D3-9A0EADC23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339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F43255-A226-4D3E-B266-1B443C2808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66A868-13D4-4160-9EA3-E208E54F7E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169FB2-8389-4E93-9287-8DF5DE577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66C2D6-6A4A-41CF-9EAB-52147664A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FF5020-19B7-4ABD-A426-DF9AD9AD0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90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CFEE1D-7A02-4DF0-889E-79E454F52D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2C5DB7-0A20-4815-813E-13A7BC9E88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A20188-9052-4528-8085-181651D7A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DA622D-C89D-4EEF-953B-15199CB52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E56D31-5E2E-4CD6-92A2-0F82AA5E5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492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1C1F0-E0D3-41E8-8C69-349A732781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2D18D9-BCBB-4D4E-90BE-EF6CB93E14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FE2E84-B4D1-4874-9F48-7416C57A2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23461-0D10-4D25-9C82-F1FF78F1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0A505-F95B-49CF-993D-B99046A42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84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952F3-DF75-4B1B-95A4-19E0D7397B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9708E1-3CAD-4D57-84ED-A90A29F797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FE1999-8389-4426-B7A6-3EE810FBFF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7EE784-4888-45CC-9F21-0993ECB5D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417D05-69AE-41B3-8E1D-664518467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AE7BF6-FC43-4520-A918-267A7800D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222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23067E-78A2-45AF-9EA9-0071B61792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B2BB6F-0082-40FD-A012-9577A55BB6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471E41-DA37-4847-84B6-81AEFA78F0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27CC91-D0C4-4028-AF99-D0E86FDB05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A1C5DD-C790-4734-9FEA-087EFC2F03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F690AB-E8B4-469F-9E4E-997C3E38E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7CBAC5-CD9A-4544-B8B1-3316E300A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8E03E4-79D8-41AC-9F62-93DC1668A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73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D7F7B5-1F31-4170-B48F-5EEAC0B91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C73330-51BC-4169-A4A3-E8C3A9820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81C04D-A678-4B7A-BB20-C7AA29C0E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255271-FABA-4081-88F3-0ED0B7701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866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564539-DA8C-4F29-B3C9-BADA85AF7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F40545-EFAC-4CD0-96E8-9F84E8301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43A729-5CC0-47E3-A5D8-35CBDF200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478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3AE978-A111-419C-BD5B-03C86ED4C6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DF7A1-BEE7-445B-A34A-6228FBBD09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6C5B95-D718-4C8A-ACF8-6B66738109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7C59AC-76B2-46E2-B53C-6EBA05A0D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4F3146-AD69-4F69-A3D5-CFD5A4625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1BDC1E-A3FE-41BA-9C97-F036000F8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065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568BF-84AB-44EA-9893-C86C34C4E8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6D928C5-E879-4576-88D8-B9DEF805D9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32414-199D-46EA-9394-940B3AF8E7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C870B8-C784-4241-A83E-D78D9C5C5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96ED6E-6143-4D2D-93DA-D913208A6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1A0DDC-FBA1-437C-9F77-F168E7FC7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160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918A5F-5A97-4B6D-B687-77C1C0C9CA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A9B010-4A5C-46C6-8B2B-A982F39060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76EBC2-C018-4B40-B328-D9FFFECCDA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A37E86-B462-49EB-B163-BEF8DEEAEA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731D1B-D21D-4594-A368-3BA62078C2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662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623DEEE-D4E7-42CC-816C-0005993BF80A}"/>
              </a:ext>
            </a:extLst>
          </p:cNvPr>
          <p:cNvSpPr txBox="1"/>
          <p:nvPr/>
        </p:nvSpPr>
        <p:spPr>
          <a:xfrm>
            <a:off x="0" y="0"/>
            <a:ext cx="2502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E2, PEPIT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BB8E39-81B0-40C3-8A58-1E10AC31457B}"/>
              </a:ext>
            </a:extLst>
          </p:cNvPr>
          <p:cNvSpPr txBox="1"/>
          <p:nvPr/>
        </p:nvSpPr>
        <p:spPr>
          <a:xfrm>
            <a:off x="4750520" y="409803"/>
            <a:ext cx="2690960" cy="4428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2700" tIns="12700" rIns="12700" bIns="12700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0 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ldren assessed for eligibility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0B8675-3A7B-479A-A9C3-1364A6D2EC3D}"/>
              </a:ext>
            </a:extLst>
          </p:cNvPr>
          <p:cNvSpPr txBox="1"/>
          <p:nvPr/>
        </p:nvSpPr>
        <p:spPr>
          <a:xfrm>
            <a:off x="4991221" y="2763025"/>
            <a:ext cx="2209559" cy="4428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2700" tIns="12700" rIns="12700" bIns="12700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6 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domiz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A2FF19D-3EE2-496D-BE28-240FBC87A037}"/>
              </a:ext>
            </a:extLst>
          </p:cNvPr>
          <p:cNvSpPr txBox="1"/>
          <p:nvPr/>
        </p:nvSpPr>
        <p:spPr>
          <a:xfrm>
            <a:off x="1638489" y="3804037"/>
            <a:ext cx="3352732" cy="5038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2700" tIns="12700" rIns="12700" bIns="12700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38 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domized to receive </a:t>
            </a:r>
            <a:r>
              <a:rPr lang="en-U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skin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anut 250 µg</a:t>
            </a:r>
          </a:p>
          <a:p>
            <a:pPr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38 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eived </a:t>
            </a:r>
            <a:r>
              <a:rPr lang="en-U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skin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anut 250 µg as randomized</a:t>
            </a:r>
            <a:endParaRPr lang="en-US" sz="1200" kern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5A6C7A6-86B0-4A9E-B2AA-A7CC813724B0}"/>
              </a:ext>
            </a:extLst>
          </p:cNvPr>
          <p:cNvSpPr txBox="1"/>
          <p:nvPr/>
        </p:nvSpPr>
        <p:spPr>
          <a:xfrm>
            <a:off x="1638490" y="4532568"/>
            <a:ext cx="3352732" cy="16363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2700" tIns="12700" rIns="12700" bIns="12700" numCol="1" spcCol="1270" anchor="t" anchorCtr="0">
            <a:noAutofit/>
          </a:bodyPr>
          <a:lstStyle/>
          <a:p>
            <a:pPr marL="0" lvl="0" indent="0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13 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leted study</a:t>
            </a:r>
          </a:p>
          <a:p>
            <a:pPr lvl="1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d not complete the study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drawal of consent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dverse event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ost to follow-up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oncompliance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ther reasons</a:t>
            </a:r>
            <a:endParaRPr lang="en-US" sz="1200" kern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E18E2AE-2AC4-45B5-8A2E-8143ABBDDD80}"/>
              </a:ext>
            </a:extLst>
          </p:cNvPr>
          <p:cNvSpPr txBox="1"/>
          <p:nvPr/>
        </p:nvSpPr>
        <p:spPr>
          <a:xfrm>
            <a:off x="1638490" y="6402395"/>
            <a:ext cx="335273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2700" tIns="12700" rIns="12700" bIns="12700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4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38 </a:t>
            </a:r>
            <a:r>
              <a:rPr lang="en-US" sz="14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luded in th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 primary efficacy </a:t>
            </a: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n-US" sz="1400" baseline="300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400" kern="120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DCB155C-588B-4EB0-B345-25EC107B85E4}"/>
              </a:ext>
            </a:extLst>
          </p:cNvPr>
          <p:cNvSpPr txBox="1"/>
          <p:nvPr/>
        </p:nvSpPr>
        <p:spPr>
          <a:xfrm>
            <a:off x="7200780" y="3804037"/>
            <a:ext cx="3352732" cy="5038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2700" tIns="12700" rIns="12700" bIns="12700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8 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domized to receive 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cebo</a:t>
            </a:r>
          </a:p>
          <a:p>
            <a:pPr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8 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eived 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cebo as randomized</a:t>
            </a:r>
            <a:endParaRPr lang="en-US" sz="1200" kern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FCD7E9D-E088-41DB-866C-897EFA03257E}"/>
              </a:ext>
            </a:extLst>
          </p:cNvPr>
          <p:cNvSpPr txBox="1"/>
          <p:nvPr/>
        </p:nvSpPr>
        <p:spPr>
          <a:xfrm>
            <a:off x="7200781" y="4532568"/>
            <a:ext cx="3352732" cy="16363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2700" tIns="12700" rIns="12700" bIns="12700" numCol="1" spcCol="1270" anchor="t" anchorCtr="0">
            <a:noAutofit/>
          </a:bodyPr>
          <a:lstStyle/>
          <a:p>
            <a:pPr marL="0" lvl="0" indent="0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7 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leted study</a:t>
            </a:r>
          </a:p>
          <a:p>
            <a:pPr lvl="1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d not complete the study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drawal of consent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ost to follow-up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vestigator decision 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ther reasons</a:t>
            </a:r>
            <a:endParaRPr lang="en-US" sz="1200" kern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6B00C62-B80E-461D-A598-097AB12E822A}"/>
              </a:ext>
            </a:extLst>
          </p:cNvPr>
          <p:cNvSpPr txBox="1"/>
          <p:nvPr/>
        </p:nvSpPr>
        <p:spPr>
          <a:xfrm>
            <a:off x="7200781" y="6402395"/>
            <a:ext cx="335273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2700" tIns="12700" rIns="12700" bIns="12700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4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8 </a:t>
            </a:r>
            <a:r>
              <a:rPr lang="en-US" sz="14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luded in th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 primary efficacy </a:t>
            </a: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n-US" sz="1400" baseline="300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400" kern="120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DF4A166-8905-4A62-A026-B840F33DA7D7}"/>
              </a:ext>
            </a:extLst>
          </p:cNvPr>
          <p:cNvSpPr txBox="1"/>
          <p:nvPr/>
        </p:nvSpPr>
        <p:spPr>
          <a:xfrm>
            <a:off x="8105846" y="369332"/>
            <a:ext cx="3352732" cy="283769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2700" tIns="12700" rIns="12700" bIns="12700" numCol="1" spcCol="1270" anchor="t" anchorCtr="0">
            <a:noAutofit/>
          </a:bodyPr>
          <a:lstStyle/>
          <a:p>
            <a:pPr marL="0" lvl="0" indent="0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4 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</a:p>
          <a:p>
            <a:pPr lvl="1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7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d not meet inclusion/exclusion </a:t>
            </a:r>
            <a:r>
              <a:rPr lang="en-US" sz="1200" kern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iteria</a:t>
            </a:r>
            <a:r>
              <a:rPr lang="en-US" sz="1200" kern="1200" baseline="300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200" kern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Unwilling/unable to comply with protocol requirements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egative DBPCFC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 Excessive anxiety/unlikely to cope with conditions of the DBPCFC</a:t>
            </a:r>
            <a:endParaRPr lang="en-US" sz="1200" kern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anut-specific IgE ≤0.7 </a:t>
            </a:r>
            <a:r>
              <a:rPr lang="en-U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U</a:t>
            </a:r>
            <a:r>
              <a:rPr lang="en-US" sz="1200" baseline="-250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evere reaction during DBPCFC</a:t>
            </a:r>
          </a:p>
          <a:p>
            <a:pPr lvl="2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</a:t>
            </a:r>
            <a:r>
              <a:rPr lang="en-US" sz="1200" baseline="300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20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1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drawal of consent</a:t>
            </a:r>
          </a:p>
          <a:p>
            <a:pPr lvl="1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dverse event</a:t>
            </a:r>
          </a:p>
          <a:p>
            <a:pPr lvl="1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ther reasons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FDE9E12-1D9F-42E5-A1CC-3E4C5CD58C72}"/>
              </a:ext>
            </a:extLst>
          </p:cNvPr>
          <p:cNvCxnSpPr>
            <a:stCxn id="6" idx="2"/>
            <a:endCxn id="7" idx="0"/>
          </p:cNvCxnSpPr>
          <p:nvPr/>
        </p:nvCxnSpPr>
        <p:spPr>
          <a:xfrm>
            <a:off x="6096000" y="852675"/>
            <a:ext cx="1" cy="1910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2EC7C2C-753A-4C0B-97F7-7150F6F5017B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 flipH="1">
            <a:off x="3314855" y="3205897"/>
            <a:ext cx="2781146" cy="5981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C65D30A-3504-46F6-97BC-24FD835EFB12}"/>
              </a:ext>
            </a:extLst>
          </p:cNvPr>
          <p:cNvCxnSpPr>
            <a:cxnSpLocks/>
            <a:stCxn id="7" idx="2"/>
            <a:endCxn id="11" idx="0"/>
          </p:cNvCxnSpPr>
          <p:nvPr/>
        </p:nvCxnSpPr>
        <p:spPr>
          <a:xfrm>
            <a:off x="6096001" y="3205897"/>
            <a:ext cx="2781145" cy="5981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54C8B1-C8F8-4BDD-B9BF-6DCDF50E92FC}"/>
              </a:ext>
            </a:extLst>
          </p:cNvPr>
          <p:cNvCxnSpPr>
            <a:stCxn id="8" idx="2"/>
            <a:endCxn id="9" idx="0"/>
          </p:cNvCxnSpPr>
          <p:nvPr/>
        </p:nvCxnSpPr>
        <p:spPr>
          <a:xfrm>
            <a:off x="3314855" y="4307865"/>
            <a:ext cx="1" cy="2247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51D7D043-88F6-46BA-8E08-AE2BDFB3A45E}"/>
              </a:ext>
            </a:extLst>
          </p:cNvPr>
          <p:cNvCxnSpPr>
            <a:cxnSpLocks/>
            <a:stCxn id="9" idx="2"/>
            <a:endCxn id="10" idx="0"/>
          </p:cNvCxnSpPr>
          <p:nvPr/>
        </p:nvCxnSpPr>
        <p:spPr>
          <a:xfrm>
            <a:off x="3314856" y="6168958"/>
            <a:ext cx="0" cy="233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5C3925EB-5419-4BBA-8CB0-569C0039026F}"/>
              </a:ext>
            </a:extLst>
          </p:cNvPr>
          <p:cNvCxnSpPr>
            <a:cxnSpLocks/>
            <a:stCxn id="11" idx="2"/>
            <a:endCxn id="12" idx="0"/>
          </p:cNvCxnSpPr>
          <p:nvPr/>
        </p:nvCxnSpPr>
        <p:spPr>
          <a:xfrm>
            <a:off x="8877146" y="4307865"/>
            <a:ext cx="1" cy="2247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28545139-4070-4650-A133-C89737C3B9D4}"/>
              </a:ext>
            </a:extLst>
          </p:cNvPr>
          <p:cNvCxnSpPr>
            <a:cxnSpLocks/>
            <a:stCxn id="12" idx="2"/>
            <a:endCxn id="13" idx="0"/>
          </p:cNvCxnSpPr>
          <p:nvPr/>
        </p:nvCxnSpPr>
        <p:spPr>
          <a:xfrm>
            <a:off x="8877147" y="6168958"/>
            <a:ext cx="0" cy="233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E5508953-7456-4068-A9C7-3E14E694FA45}"/>
              </a:ext>
            </a:extLst>
          </p:cNvPr>
          <p:cNvCxnSpPr>
            <a:cxnSpLocks/>
            <a:endCxn id="14" idx="1"/>
          </p:cNvCxnSpPr>
          <p:nvPr/>
        </p:nvCxnSpPr>
        <p:spPr>
          <a:xfrm>
            <a:off x="6096000" y="1788179"/>
            <a:ext cx="20098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78845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0910E230E33434A8F72B935337CA89F" ma:contentTypeVersion="12" ma:contentTypeDescription="Create a new document." ma:contentTypeScope="" ma:versionID="b3ff08a6f125daa8ebdd740d7b02ce8d">
  <xsd:schema xmlns:xsd="http://www.w3.org/2001/XMLSchema" xmlns:xs="http://www.w3.org/2001/XMLSchema" xmlns:p="http://schemas.microsoft.com/office/2006/metadata/properties" xmlns:ns2="95734648-81ed-4cb3-86b2-a255be970428" xmlns:ns3="e2ccda8d-dc0e-4ba9-a702-5fb58a589676" targetNamespace="http://schemas.microsoft.com/office/2006/metadata/properties" ma:root="true" ma:fieldsID="a265fdcba77d5f8ff2fc6162e3c01732" ns2:_="" ns3:_="">
    <xsd:import namespace="95734648-81ed-4cb3-86b2-a255be970428"/>
    <xsd:import namespace="e2ccda8d-dc0e-4ba9-a702-5fb58a58967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EventHashCode" minOccurs="0"/>
                <xsd:element ref="ns2:MediaServiceGenerationTime" minOccurs="0"/>
                <xsd:element ref="ns2:MediaServiceAutoTags" minOccurs="0"/>
                <xsd:element ref="ns2:MediaServiceOCR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5734648-81ed-4cb3-86b2-a255be97042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Tags" ma:index="14" nillable="true" ma:displayName="MediaServiceAutoTags" ma:internalName="MediaServiceAutoTags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2ccda8d-dc0e-4ba9-a702-5fb58a589676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F64C1B8-775C-48F7-8B34-677F4762532C}">
  <ds:schemaRefs>
    <ds:schemaRef ds:uri="http://purl.org/dc/dcmitype/"/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terms/"/>
    <ds:schemaRef ds:uri="http://www.w3.org/XML/1998/namespace"/>
    <ds:schemaRef ds:uri="http://schemas.microsoft.com/office/infopath/2007/PartnerControls"/>
    <ds:schemaRef ds:uri="http://schemas.openxmlformats.org/package/2006/metadata/core-properties"/>
    <ds:schemaRef ds:uri="1b8c0a43-fee0-4e1c-bf87-ca768e4d5fff"/>
    <ds:schemaRef ds:uri="a70e900c-8360-41e2-bb31-4c3e814607f3"/>
  </ds:schemaRefs>
</ds:datastoreItem>
</file>

<file path=customXml/itemProps2.xml><?xml version="1.0" encoding="utf-8"?>
<ds:datastoreItem xmlns:ds="http://schemas.openxmlformats.org/officeDocument/2006/customXml" ds:itemID="{A50E1AD5-9636-451C-B5B2-6578A38AC58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5734648-81ed-4cb3-86b2-a255be970428"/>
    <ds:schemaRef ds:uri="e2ccda8d-dc0e-4ba9-a702-5fb58a58967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AA79E53-8777-4502-99DF-CF71D422ABD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60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orbidities Manuscript Figures</dc:title>
  <dc:creator>Paula Davis</dc:creator>
  <cp:lastModifiedBy>Dianne Campbell</cp:lastModifiedBy>
  <cp:revision>23</cp:revision>
  <dcterms:created xsi:type="dcterms:W3CDTF">2020-10-15T21:56:15Z</dcterms:created>
  <dcterms:modified xsi:type="dcterms:W3CDTF">2022-07-07T06:19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0910E230E33434A8F72B935337CA89F</vt:lpwstr>
  </property>
</Properties>
</file>